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CC67596-C9D2-CDF7-4F98-FB25DB6A79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FC67AF2D-70E3-7651-AEDD-6EBAE47F1E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2C31A92-F0D0-4A3B-57B6-81508DD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079B4F84-D29B-8800-5814-BD6BEB626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B4E583D-108D-2C3D-BBA8-04040C6D0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28673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22F56AF-2310-AA07-0754-2FB1D88135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83754672-48B5-42F1-0550-54030FE8DF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35AA2106-9D9F-AD84-6708-24D31659A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0F638DD4-DE81-B3B8-7C27-1938C165A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F15DBE2-F31A-580C-5D99-8011A220B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96856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0F774496-70A0-905B-6E66-8F0A947093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4EED2438-A06F-CFEE-8F32-EA13677082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86C6648-6189-B451-A6C8-455CE94F3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83BEA73-3E0B-AFFA-0684-824CC4CE2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7DF6A67-C7BA-0907-3C19-5D1E40D41D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30274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BC0C1B1-9FB5-07B7-3042-FBF11B750A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06EF8C75-DC53-2F63-334C-E9DA8CABE7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22125F6-6853-6D05-201C-B276A167E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BF96E835-F4EF-03F3-4009-138A7AB50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88433BB-49FA-4F58-C0EF-F0F605FF2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21536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9AB5A4D-2A29-9FAF-BC45-8D49931387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5E9F15D4-35E7-B0CC-4741-02E1868BCF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1B5A567E-0FA8-8816-6D69-062B8A819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0E22C57-E76D-E3F1-6941-50566B024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13743A43-4399-25E5-6EF4-FF41DD1E2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28259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96D39EA-D695-C5DD-1D69-D907FF31EA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0EDC884D-B80A-6AAF-ED29-7FED1B1A51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D87917E6-E194-48B8-1816-069DA251BE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CE06090C-6381-48C0-C441-36384A721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6182E717-39C8-559B-BF58-4306033B6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BE05321-7D2D-3C50-5927-B804B1371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57859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104FD0B-1DE7-BFDD-D0BE-AB9822393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BB867B4E-B532-55C8-7C5E-261EA1DC88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0D1A6F00-7A31-51AF-C8AC-E3C675D1FC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D7FB3387-D3F7-DC9A-A595-448D1AC36D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D3A6D142-4696-005B-2CCD-542FE25A34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E726170C-E984-DF4D-0D77-443837C36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88809478-3FBF-711C-3E6C-9755537AC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54AF35A1-2447-C06C-8382-FCB04D134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84781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55FCDEC-4E31-8F93-B853-5AE79ABA59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13796190-2616-37A6-958E-099FF0177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85092DA5-0935-F123-0159-2ECBC1205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E8C26529-0B2C-2574-1993-1139965084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18075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BD38827D-488A-E188-7F22-1EF28F14C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FA37F905-2CB2-64D1-8C5A-A845CFDEC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90CE7B1C-DCAC-EB50-6768-78D5B51D9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52973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85741E4-78AF-D893-7905-AE3BDB7F0B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247C7041-8AB1-06D2-3426-CB7F530E43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3FE87D32-81E3-784B-0EA5-6BD4F07A9A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245D953-D283-33E4-DC59-77CAEF093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87834D7B-3FB6-469A-882B-B1AA3EDA8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3410A0F9-3739-99DB-77D8-12B37E5BE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91330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4D59E80-A3D0-DF4C-370B-00C2354CB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92AAED2C-8C71-A9C4-4F46-87008A5B04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66E7E2FE-DE3F-4E2F-56B8-DD6F29C686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77EA6FDF-3E0B-DE34-0457-5FB8088B8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63338597-650F-665F-5234-22613A2FD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92BAA7D6-5B26-CCCF-4224-2D986CEC5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79160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5AF44155-F574-C6F0-BD1C-C383D6BDFA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6760DA07-A3D7-AB42-6FE4-7ADCD4A28A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6B7425B-E3E8-93A0-2E6D-8B3B32075F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EC43B-52D8-45F2-9986-D23AF6F63344}" type="datetimeFigureOut">
              <a:rPr lang="hu-HU" smtClean="0"/>
              <a:t>2023. 04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154563E-E7B3-1EA2-15AA-EFEB0BD2C6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F552FE00-0F93-5212-BD8B-23F124B73B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41FA7D-0115-4359-ABF5-699468CB218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36466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F7C6C5A-E2E0-D9E6-19FD-BA5FF7971F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3932809" y="4215397"/>
            <a:ext cx="3977198" cy="469799"/>
          </a:xfrm>
        </p:spPr>
        <p:txBody>
          <a:bodyPr>
            <a:normAutofit fontScale="90000"/>
          </a:bodyPr>
          <a:lstStyle/>
          <a:p>
            <a:r>
              <a:rPr lang="hu-HU" sz="1400" dirty="0"/>
              <a:t>         </a:t>
            </a:r>
            <a:r>
              <a:rPr lang="hu-HU" sz="1400" dirty="0" err="1"/>
              <a:t>wild-type</a:t>
            </a:r>
            <a:r>
              <a:rPr lang="hu-HU" sz="1400" dirty="0"/>
              <a:t> </a:t>
            </a:r>
            <a:r>
              <a:rPr lang="hu-HU" sz="1400" dirty="0" err="1"/>
              <a:t>strain</a:t>
            </a:r>
            <a:r>
              <a:rPr lang="hu-HU" sz="1400" dirty="0"/>
              <a:t>         333             334          335 </a:t>
            </a:r>
            <a:br>
              <a:rPr lang="hu-HU" sz="1400" dirty="0"/>
            </a:br>
            <a:r>
              <a:rPr lang="hu-HU" sz="1400" dirty="0"/>
              <a:t>                                        </a:t>
            </a:r>
            <a:r>
              <a:rPr lang="hu-HU" sz="1400" dirty="0" err="1"/>
              <a:t>mutant</a:t>
            </a:r>
            <a:r>
              <a:rPr lang="hu-HU" sz="1400" dirty="0"/>
              <a:t> </a:t>
            </a:r>
            <a:r>
              <a:rPr lang="hu-HU" sz="1400" dirty="0" err="1"/>
              <a:t>strains</a:t>
            </a:r>
            <a:endParaRPr lang="hu-HU" sz="1400" dirty="0"/>
          </a:p>
        </p:txBody>
      </p:sp>
      <p:pic>
        <p:nvPicPr>
          <p:cNvPr id="4" name="Kép 3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3930"/>
          <a:stretch/>
        </p:blipFill>
        <p:spPr>
          <a:xfrm>
            <a:off x="4030462" y="540192"/>
            <a:ext cx="4495238" cy="3701838"/>
          </a:xfrm>
          <a:prstGeom prst="rect">
            <a:avLst/>
          </a:prstGeom>
        </p:spPr>
      </p:pic>
      <p:sp>
        <p:nvSpPr>
          <p:cNvPr id="5" name="Szövegdoboz 4">
            <a:extLst>
              <a:ext uri="{FF2B5EF4-FFF2-40B4-BE49-F238E27FC236}">
                <a16:creationId xmlns:a16="http://schemas.microsoft.com/office/drawing/2014/main" id="{E4092B02-FA89-4EF5-8CB1-8C204D6D375E}"/>
              </a:ext>
            </a:extLst>
          </p:cNvPr>
          <p:cNvSpPr txBox="1"/>
          <p:nvPr/>
        </p:nvSpPr>
        <p:spPr>
          <a:xfrm>
            <a:off x="4296792" y="949911"/>
            <a:ext cx="5237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dirty="0"/>
              <a:t>cm</a:t>
            </a:r>
          </a:p>
        </p:txBody>
      </p:sp>
      <p:sp>
        <p:nvSpPr>
          <p:cNvPr id="3" name="Szövegdoboz 2">
            <a:extLst>
              <a:ext uri="{FF2B5EF4-FFF2-40B4-BE49-F238E27FC236}">
                <a16:creationId xmlns:a16="http://schemas.microsoft.com/office/drawing/2014/main" id="{98F35446-E77C-C9D6-B0BC-11BFF7BBD2AE}"/>
              </a:ext>
            </a:extLst>
          </p:cNvPr>
          <p:cNvSpPr txBox="1"/>
          <p:nvPr/>
        </p:nvSpPr>
        <p:spPr>
          <a:xfrm>
            <a:off x="945474" y="4932893"/>
            <a:ext cx="99518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Figure S</a:t>
            </a:r>
            <a:r>
              <a:rPr lang="hu-HU" dirty="0"/>
              <a:t>3</a:t>
            </a:r>
            <a:r>
              <a:rPr lang="en-AU" dirty="0"/>
              <a:t>: The length of hyphae </a:t>
            </a:r>
            <a:r>
              <a:rPr lang="hu-HU" dirty="0" err="1"/>
              <a:t>was</a:t>
            </a:r>
            <a:r>
              <a:rPr lang="en-AU" dirty="0"/>
              <a:t> significantly shorter in the mutant strains, compared to the wild-type strain. </a:t>
            </a:r>
            <a:r>
              <a:rPr lang="en-AU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Kruskal-Wallis test, </a:t>
            </a:r>
            <a:r>
              <a:rPr lang="en-AU" dirty="0">
                <a:solidFill>
                  <a:srgbClr val="000000"/>
                </a:solidFill>
                <a:latin typeface="Calibri" panose="020F0502020204030204" pitchFamily="34" charset="0"/>
              </a:rPr>
              <a:t>p value</a:t>
            </a:r>
            <a:r>
              <a:rPr lang="en-AU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:1.76E-07. Dunn post hoc with Bonferroni correction,</a:t>
            </a:r>
            <a:r>
              <a:rPr lang="en-AU" dirty="0"/>
              <a:t> </a:t>
            </a:r>
            <a:r>
              <a:rPr lang="en-AU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6,35E-05</a:t>
            </a:r>
            <a:r>
              <a:rPr lang="en-AU" dirty="0"/>
              <a:t> (333), </a:t>
            </a:r>
            <a:r>
              <a:rPr lang="en-AU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,31E-07</a:t>
            </a:r>
            <a:r>
              <a:rPr lang="en-AU" dirty="0"/>
              <a:t> (334), </a:t>
            </a:r>
            <a:r>
              <a:rPr lang="en-AU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3,00E-05</a:t>
            </a:r>
            <a:r>
              <a:rPr lang="en-AU" dirty="0"/>
              <a:t> (335).</a:t>
            </a:r>
          </a:p>
        </p:txBody>
      </p:sp>
    </p:spTree>
    <p:extLst>
      <p:ext uri="{BB962C8B-B14F-4D97-AF65-F5344CB8AC3E}">
        <p14:creationId xmlns:p14="http://schemas.microsoft.com/office/powerpoint/2010/main" val="2090243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60</Words>
  <Application>Microsoft Office PowerPoint</Application>
  <PresentationFormat>Szélesvásznú</PresentationFormat>
  <Paragraphs>3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         wild-type strain         333             334          335                                          mutant strain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Gálné dr. Miklós Ida</dc:creator>
  <cp:lastModifiedBy>Gálné dr. Miklós Ida</cp:lastModifiedBy>
  <cp:revision>15</cp:revision>
  <dcterms:created xsi:type="dcterms:W3CDTF">2023-03-09T17:11:02Z</dcterms:created>
  <dcterms:modified xsi:type="dcterms:W3CDTF">2023-04-14T14:51:00Z</dcterms:modified>
</cp:coreProperties>
</file>